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ikshya Sapkota" userId="76d3f829-1b89-41c2-8bc2-064e2010091f" providerId="ADAL" clId="{959C9C4C-E629-4ACA-B74A-DB5236194035}"/>
    <pc:docChg chg="modSld">
      <pc:chgData name="Dikshya Sapkota" userId="76d3f829-1b89-41c2-8bc2-064e2010091f" providerId="ADAL" clId="{959C9C4C-E629-4ACA-B74A-DB5236194035}" dt="2023-06-18T16:42:56.460" v="1" actId="20577"/>
      <pc:docMkLst>
        <pc:docMk/>
      </pc:docMkLst>
      <pc:sldChg chg="modSp mod">
        <pc:chgData name="Dikshya Sapkota" userId="76d3f829-1b89-41c2-8bc2-064e2010091f" providerId="ADAL" clId="{959C9C4C-E629-4ACA-B74A-DB5236194035}" dt="2023-06-18T16:42:56.460" v="1" actId="20577"/>
        <pc:sldMkLst>
          <pc:docMk/>
          <pc:sldMk cId="1712053774" sldId="256"/>
        </pc:sldMkLst>
        <pc:spChg chg="mod">
          <ac:chgData name="Dikshya Sapkota" userId="76d3f829-1b89-41c2-8bc2-064e2010091f" providerId="ADAL" clId="{959C9C4C-E629-4ACA-B74A-DB5236194035}" dt="2023-06-18T16:42:56.460" v="1" actId="20577"/>
          <ac:spMkLst>
            <pc:docMk/>
            <pc:sldMk cId="1712053774" sldId="256"/>
            <ac:spMk id="5" creationId="{F40B3A4A-37AF-2787-F8DA-D60939234CD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1CFC11-9C33-AC54-F951-BF3082EA18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9B994B-70EB-639C-5029-F4410FC89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330B32-80DD-52F4-799F-8546A9EF3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C97B15-C007-5FA4-DF8E-9012099B3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405D01-B03A-4ACB-923B-1A111615D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808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295078-6D91-808F-3782-93A1C82683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0696D4-0CF8-C27A-631A-2237A8E3D1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3B716E-4AB6-D310-3BDF-FDD4EAFF6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CBA958-4CE1-4542-2F96-2E7FEF671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4CC294-F182-D68E-8C1C-4D362BF5B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879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63C8A6-5835-CACE-E3D0-7890ABF0C5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89BFB2-0EA6-2B38-CFFC-3C135B372E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EB8BCF-FC65-99C2-D538-1A7BB645E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3CC103-4120-4F3C-066E-251CF6932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6178A5-4924-809C-67CE-D22F5D5C9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308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0B8F0-98CE-7764-9E81-19675D81F1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3ABB17-AF6B-A100-47AB-7D89E40CD0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08C04B-49F3-AE43-F027-780D472E7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E2B615-C5DB-9F05-3911-D7FDF1AD9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5FF3EB-5E82-2B7A-53F5-0BA944309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521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F195DD-A1F0-E36B-9CB8-3D356136E1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083CB3-C276-C53B-F075-E964B77D23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A1F833-0B0A-C986-695D-99FECEF32C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367B1C-AC90-5497-E156-6850314BB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2E99DD-5B14-58EB-0BB3-D7E14F102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740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3AEBE4-D4DD-2FAF-65FA-BA83BBFDCA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2EA1E0-2B02-1720-044E-A5BD7CCDE4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865144-BD7C-10B9-D026-325A841667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CF3255-F5F9-4C20-5A4A-0AEBCC9D9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A32309-85E1-0FB6-13E3-C990E0C0A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1B7BF7-FAE2-ECC6-0512-CC7CD45EA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349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6E3CC0-EB48-0982-5E4E-B42277747C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74621B-BB6E-9335-2B7B-E2D717D551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DF8D52-B658-0C51-2206-7287E0022E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01E2AE-2557-506D-D657-397184A230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1598247-66CC-0F59-6DF7-395E61B646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692325-AC10-2EDA-83BF-D84694FA8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1974BD-3EA6-E306-014B-67B971F48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852971-45E3-94B4-E2BB-08075246D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692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9392C8-B589-DC61-A2EE-BC9AADB05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FDD3EE-1C25-6D53-DEFC-8D7DFF464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25D343-343A-2F23-BD20-3B46529A0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D5F96D-97BE-1831-7B9E-52820514D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904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384C097-EB68-6466-234D-DA558661C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D0D216-DFDC-C2CF-B80B-872CD048B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9F81C0-820B-9B9B-A265-BEC1624CD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760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ECB3AB-3F25-3D67-C691-22F2184ABB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72F246-D7B5-B8A4-D9DA-4E635716CF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4CD552-B13D-CCD8-B9C0-20D63A3BD0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D0378A-4450-12B7-88A4-4FC2BE433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967B96-34FC-68F3-A179-BCE982DAA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BDBE0E-5582-4FE7-00CD-C269F37B8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370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1991E0-6174-EB55-060D-9DE428C0DA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D3D6E0-A1D2-5AD3-49FA-EF1AB46B99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30658A-EBA8-C3E9-546D-8C866711F9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F351D1-D48D-EF3A-D101-D48F4004C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CFF7ED-2E66-5CF3-3E04-64A196C8A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CD95E2-CB15-A27D-827D-B9141D5A9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022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9A0920-1995-6908-D0EE-74F381BD2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69D025-2C85-F2B8-F5FC-55893D83BA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6B693B-41C8-0ACF-01A3-3C39269ECA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C4E04D-263A-489B-88B9-8668BBC67230}" type="datetimeFigureOut">
              <a:rPr lang="en-US" smtClean="0"/>
              <a:t>21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3F6269-6550-D21B-FA73-44FD52163F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5A2914-452F-F601-E58A-6BA7355EE2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909047-FA0B-4608-8321-2559A2B1A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318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292D6D6-56FD-81A4-F5BB-F0EE079065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534" y="1054139"/>
            <a:ext cx="8458311" cy="331258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40B3A4A-37AF-2787-F8DA-D60939234CD2}"/>
              </a:ext>
            </a:extLst>
          </p:cNvPr>
          <p:cNvSpPr txBox="1"/>
          <p:nvPr/>
        </p:nvSpPr>
        <p:spPr>
          <a:xfrm>
            <a:off x="1468016" y="4506906"/>
            <a:ext cx="92559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Z. spinosa</a:t>
            </a:r>
            <a:r>
              <a:rPr lang="en-US" sz="2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fruit vs accessions of admixture fruit with brighter fruit color and more wrinkles (thick flesh) on fruit surface. From left to right: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Z. spinosa</a:t>
            </a:r>
            <a:r>
              <a:rPr lang="en-US" sz="2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fruit from NMSU campus 21NM9, admixture accessions of 22TX53 and 22TX69</a:t>
            </a:r>
            <a:r>
              <a:rPr lang="en-US" sz="20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712053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A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onymous</dc:creator>
  <cp:lastModifiedBy>MDPI</cp:lastModifiedBy>
  <cp:revision>2</cp:revision>
  <dcterms:created xsi:type="dcterms:W3CDTF">2023-05-08T18:13:46Z</dcterms:created>
  <dcterms:modified xsi:type="dcterms:W3CDTF">2023-06-21T15:37:41Z</dcterms:modified>
</cp:coreProperties>
</file>